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64" r:id="rId2"/>
    <p:sldId id="261" r:id="rId3"/>
    <p:sldId id="263" r:id="rId4"/>
    <p:sldId id="260" r:id="rId5"/>
    <p:sldId id="259" r:id="rId6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stefano ferroni" initials="sf" lastIdx="1" clrIdx="0">
    <p:extLst>
      <p:ext uri="{19B8F6BF-5375-455C-9EA6-DF929625EA0E}">
        <p15:presenceInfo xmlns:p15="http://schemas.microsoft.com/office/powerpoint/2012/main" userId="3097ad9eec74a2ff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235" autoAdjust="0"/>
    <p:restoredTop sz="94668" autoAdjust="0"/>
  </p:normalViewPr>
  <p:slideViewPr>
    <p:cSldViewPr snapToGrid="0">
      <p:cViewPr>
        <p:scale>
          <a:sx n="79" d="100"/>
          <a:sy n="79" d="100"/>
        </p:scale>
        <p:origin x="2004" y="-3006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Francesco Formaggio" userId="eb0bed3e-48f3-4361-a681-36d3be15292f" providerId="ADAL" clId="{564546C1-96C6-4BA0-94BB-EA6718F14DC1}"/>
    <pc:docChg chg="undo custSel modSld">
      <pc:chgData name="Francesco Formaggio" userId="eb0bed3e-48f3-4361-a681-36d3be15292f" providerId="ADAL" clId="{564546C1-96C6-4BA0-94BB-EA6718F14DC1}" dt="2021-09-02T06:32:32.852" v="31" actId="1037"/>
      <pc:docMkLst>
        <pc:docMk/>
      </pc:docMkLst>
      <pc:sldChg chg="modSp mod">
        <pc:chgData name="Francesco Formaggio" userId="eb0bed3e-48f3-4361-a681-36d3be15292f" providerId="ADAL" clId="{564546C1-96C6-4BA0-94BB-EA6718F14DC1}" dt="2021-09-02T06:32:32.852" v="31" actId="1037"/>
        <pc:sldMkLst>
          <pc:docMk/>
          <pc:sldMk cId="3132613363" sldId="259"/>
        </pc:sldMkLst>
        <pc:spChg chg="mod">
          <ac:chgData name="Francesco Formaggio" userId="eb0bed3e-48f3-4361-a681-36d3be15292f" providerId="ADAL" clId="{564546C1-96C6-4BA0-94BB-EA6718F14DC1}" dt="2021-09-02T06:32:28.044" v="20" actId="1037"/>
          <ac:spMkLst>
            <pc:docMk/>
            <pc:sldMk cId="3132613363" sldId="259"/>
            <ac:spMk id="10" creationId="{E36B7F7B-58F1-469C-901B-A2594E7C4B52}"/>
          </ac:spMkLst>
        </pc:spChg>
        <pc:spChg chg="mod">
          <ac:chgData name="Francesco Formaggio" userId="eb0bed3e-48f3-4361-a681-36d3be15292f" providerId="ADAL" clId="{564546C1-96C6-4BA0-94BB-EA6718F14DC1}" dt="2021-09-02T06:32:32.852" v="31" actId="1037"/>
          <ac:spMkLst>
            <pc:docMk/>
            <pc:sldMk cId="3132613363" sldId="259"/>
            <ac:spMk id="12" creationId="{BCBE0FE5-BF91-473A-8B69-D52D0EF845A9}"/>
          </ac:spMkLst>
        </pc:spChg>
        <pc:spChg chg="mod">
          <ac:chgData name="Francesco Formaggio" userId="eb0bed3e-48f3-4361-a681-36d3be15292f" providerId="ADAL" clId="{564546C1-96C6-4BA0-94BB-EA6718F14DC1}" dt="2021-09-02T06:27:19.227" v="3" actId="113"/>
          <ac:spMkLst>
            <pc:docMk/>
            <pc:sldMk cId="3132613363" sldId="259"/>
            <ac:spMk id="19" creationId="{67194AC3-08A8-4B55-9E0D-D83C5BEBFF90}"/>
          </ac:spMkLst>
        </pc:spChg>
      </pc:sldChg>
      <pc:sldChg chg="modSp mod">
        <pc:chgData name="Francesco Formaggio" userId="eb0bed3e-48f3-4361-a681-36d3be15292f" providerId="ADAL" clId="{564546C1-96C6-4BA0-94BB-EA6718F14DC1}" dt="2021-09-02T06:31:24.052" v="18" actId="1035"/>
        <pc:sldMkLst>
          <pc:docMk/>
          <pc:sldMk cId="3512133905" sldId="260"/>
        </pc:sldMkLst>
        <pc:spChg chg="mod">
          <ac:chgData name="Francesco Formaggio" userId="eb0bed3e-48f3-4361-a681-36d3be15292f" providerId="ADAL" clId="{564546C1-96C6-4BA0-94BB-EA6718F14DC1}" dt="2021-09-02T06:31:24.052" v="18" actId="1035"/>
          <ac:spMkLst>
            <pc:docMk/>
            <pc:sldMk cId="3512133905" sldId="260"/>
            <ac:spMk id="5" creationId="{0E80E644-2374-41D8-AC96-5E20648B6D93}"/>
          </ac:spMkLst>
        </pc:spChg>
        <pc:spChg chg="mod">
          <ac:chgData name="Francesco Formaggio" userId="eb0bed3e-48f3-4361-a681-36d3be15292f" providerId="ADAL" clId="{564546C1-96C6-4BA0-94BB-EA6718F14DC1}" dt="2021-09-02T06:27:44.853" v="6" actId="255"/>
          <ac:spMkLst>
            <pc:docMk/>
            <pc:sldMk cId="3512133905" sldId="260"/>
            <ac:spMk id="7" creationId="{A34046C9-26A9-477B-9845-B7029FD673B7}"/>
          </ac:spMkLst>
        </pc:spChg>
        <pc:spChg chg="mod">
          <ac:chgData name="Francesco Formaggio" userId="eb0bed3e-48f3-4361-a681-36d3be15292f" providerId="ADAL" clId="{564546C1-96C6-4BA0-94BB-EA6718F14DC1}" dt="2021-09-02T06:27:44.853" v="6" actId="255"/>
          <ac:spMkLst>
            <pc:docMk/>
            <pc:sldMk cId="3512133905" sldId="260"/>
            <ac:spMk id="9" creationId="{3D55D206-B1CD-48F9-B782-D325E71ACF12}"/>
          </ac:spMkLst>
        </pc:spChg>
        <pc:spChg chg="mod">
          <ac:chgData name="Francesco Formaggio" userId="eb0bed3e-48f3-4361-a681-36d3be15292f" providerId="ADAL" clId="{564546C1-96C6-4BA0-94BB-EA6718F14DC1}" dt="2021-09-02T06:30:52.252" v="13" actId="1076"/>
          <ac:spMkLst>
            <pc:docMk/>
            <pc:sldMk cId="3512133905" sldId="260"/>
            <ac:spMk id="12" creationId="{FADD714F-EE4B-4C2E-ADE3-65AF69A431AB}"/>
          </ac:spMkLst>
        </pc:spChg>
        <pc:spChg chg="mod">
          <ac:chgData name="Francesco Formaggio" userId="eb0bed3e-48f3-4361-a681-36d3be15292f" providerId="ADAL" clId="{564546C1-96C6-4BA0-94BB-EA6718F14DC1}" dt="2021-09-02T06:31:07.925" v="15" actId="1076"/>
          <ac:spMkLst>
            <pc:docMk/>
            <pc:sldMk cId="3512133905" sldId="260"/>
            <ac:spMk id="18" creationId="{2E58EB28-740C-4E8A-BB69-4BF3398A141F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6FFB660-5A81-42FB-A379-70DA0D4AF3DF}" type="datetimeFigureOut">
              <a:rPr lang="en-GB" smtClean="0"/>
              <a:t>11/10/2021</a:t>
            </a:fld>
            <a:endParaRPr lang="en-GB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13785B-7554-44C7-A46A-46C7510A9BFC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90889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5"/>
            <a:ext cx="5143500" cy="2943577"/>
          </a:xfrm>
        </p:spPr>
        <p:txBody>
          <a:bodyPr/>
          <a:lstStyle>
            <a:lvl1pPr marL="0" indent="0" algn="ctr">
              <a:buNone/>
              <a:defRPr sz="1801"/>
            </a:lvl1pPr>
            <a:lvl2pPr marL="342913" indent="0" algn="ctr">
              <a:buNone/>
              <a:defRPr sz="1500"/>
            </a:lvl2pPr>
            <a:lvl3pPr marL="685827" indent="0" algn="ctr">
              <a:buNone/>
              <a:defRPr sz="1349"/>
            </a:lvl3pPr>
            <a:lvl4pPr marL="1028738" indent="0" algn="ctr">
              <a:buNone/>
              <a:defRPr sz="1200"/>
            </a:lvl4pPr>
            <a:lvl5pPr marL="1371653" indent="0" algn="ctr">
              <a:buNone/>
              <a:defRPr sz="1200"/>
            </a:lvl5pPr>
            <a:lvl6pPr marL="1714564" indent="0" algn="ctr">
              <a:buNone/>
              <a:defRPr sz="1200"/>
            </a:lvl6pPr>
            <a:lvl7pPr marL="2057478" indent="0" algn="ctr">
              <a:buNone/>
              <a:defRPr sz="1200"/>
            </a:lvl7pPr>
            <a:lvl8pPr marL="2400391" indent="0" algn="ctr">
              <a:buNone/>
              <a:defRPr sz="1200"/>
            </a:lvl8pPr>
            <a:lvl9pPr marL="2743302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8610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539555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50224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17988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8159055"/>
            <a:ext cx="5915025" cy="2666999"/>
          </a:xfrm>
        </p:spPr>
        <p:txBody>
          <a:bodyPr/>
          <a:lstStyle>
            <a:lvl1pPr marL="0" indent="0">
              <a:buNone/>
              <a:defRPr sz="1801">
                <a:solidFill>
                  <a:schemeClr val="tx1"/>
                </a:solidFill>
              </a:defRPr>
            </a:lvl1pPr>
            <a:lvl2pPr marL="34291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27" indent="0">
              <a:buNone/>
              <a:defRPr sz="1349">
                <a:solidFill>
                  <a:schemeClr val="tx1">
                    <a:tint val="75000"/>
                  </a:schemeClr>
                </a:solidFill>
              </a:defRPr>
            </a:lvl3pPr>
            <a:lvl4pPr marL="102873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5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6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7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9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30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028828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9186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9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5" y="2988734"/>
            <a:ext cx="2901255" cy="1464732"/>
          </a:xfrm>
        </p:spPr>
        <p:txBody>
          <a:bodyPr anchor="b"/>
          <a:lstStyle>
            <a:lvl1pPr marL="0" indent="0">
              <a:buNone/>
              <a:defRPr sz="1801" b="1"/>
            </a:lvl1pPr>
            <a:lvl2pPr marL="342913" indent="0">
              <a:buNone/>
              <a:defRPr sz="1500" b="1"/>
            </a:lvl2pPr>
            <a:lvl3pPr marL="685827" indent="0">
              <a:buNone/>
              <a:defRPr sz="1349" b="1"/>
            </a:lvl3pPr>
            <a:lvl4pPr marL="1028738" indent="0">
              <a:buNone/>
              <a:defRPr sz="1200" b="1"/>
            </a:lvl4pPr>
            <a:lvl5pPr marL="1371653" indent="0">
              <a:buNone/>
              <a:defRPr sz="1200" b="1"/>
            </a:lvl5pPr>
            <a:lvl6pPr marL="1714564" indent="0">
              <a:buNone/>
              <a:defRPr sz="1200" b="1"/>
            </a:lvl6pPr>
            <a:lvl7pPr marL="2057478" indent="0">
              <a:buNone/>
              <a:defRPr sz="1200" b="1"/>
            </a:lvl7pPr>
            <a:lvl8pPr marL="2400391" indent="0">
              <a:buNone/>
              <a:defRPr sz="1200" b="1"/>
            </a:lvl8pPr>
            <a:lvl9pPr marL="274330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5" y="4453470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988734"/>
            <a:ext cx="2915543" cy="1464732"/>
          </a:xfrm>
        </p:spPr>
        <p:txBody>
          <a:bodyPr anchor="b"/>
          <a:lstStyle>
            <a:lvl1pPr marL="0" indent="0">
              <a:buNone/>
              <a:defRPr sz="1801" b="1"/>
            </a:lvl1pPr>
            <a:lvl2pPr marL="342913" indent="0">
              <a:buNone/>
              <a:defRPr sz="1500" b="1"/>
            </a:lvl2pPr>
            <a:lvl3pPr marL="685827" indent="0">
              <a:buNone/>
              <a:defRPr sz="1349" b="1"/>
            </a:lvl3pPr>
            <a:lvl4pPr marL="1028738" indent="0">
              <a:buNone/>
              <a:defRPr sz="1200" b="1"/>
            </a:lvl4pPr>
            <a:lvl5pPr marL="1371653" indent="0">
              <a:buNone/>
              <a:defRPr sz="1200" b="1"/>
            </a:lvl5pPr>
            <a:lvl6pPr marL="1714564" indent="0">
              <a:buNone/>
              <a:defRPr sz="1200" b="1"/>
            </a:lvl6pPr>
            <a:lvl7pPr marL="2057478" indent="0">
              <a:buNone/>
              <a:defRPr sz="1200" b="1"/>
            </a:lvl7pPr>
            <a:lvl8pPr marL="2400391" indent="0">
              <a:buNone/>
              <a:defRPr sz="1200" b="1"/>
            </a:lvl8pPr>
            <a:lvl9pPr marL="2743302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4453470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83031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95475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355960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7" y="1755430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1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13" indent="0">
              <a:buNone/>
              <a:defRPr sz="1051"/>
            </a:lvl2pPr>
            <a:lvl3pPr marL="685827" indent="0">
              <a:buNone/>
              <a:defRPr sz="900"/>
            </a:lvl3pPr>
            <a:lvl4pPr marL="1028738" indent="0">
              <a:buNone/>
              <a:defRPr sz="750"/>
            </a:lvl4pPr>
            <a:lvl5pPr marL="1371653" indent="0">
              <a:buNone/>
              <a:defRPr sz="750"/>
            </a:lvl5pPr>
            <a:lvl6pPr marL="1714564" indent="0">
              <a:buNone/>
              <a:defRPr sz="750"/>
            </a:lvl6pPr>
            <a:lvl7pPr marL="2057478" indent="0">
              <a:buNone/>
              <a:defRPr sz="750"/>
            </a:lvl7pPr>
            <a:lvl8pPr marL="2400391" indent="0">
              <a:buNone/>
              <a:defRPr sz="750"/>
            </a:lvl8pPr>
            <a:lvl9pPr marL="2743302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859185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7" y="1755430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13" indent="0">
              <a:buNone/>
              <a:defRPr sz="2100"/>
            </a:lvl2pPr>
            <a:lvl3pPr marL="685827" indent="0">
              <a:buNone/>
              <a:defRPr sz="1801"/>
            </a:lvl3pPr>
            <a:lvl4pPr marL="1028738" indent="0">
              <a:buNone/>
              <a:defRPr sz="1500"/>
            </a:lvl4pPr>
            <a:lvl5pPr marL="1371653" indent="0">
              <a:buNone/>
              <a:defRPr sz="1500"/>
            </a:lvl5pPr>
            <a:lvl6pPr marL="1714564" indent="0">
              <a:buNone/>
              <a:defRPr sz="1500"/>
            </a:lvl6pPr>
            <a:lvl7pPr marL="2057478" indent="0">
              <a:buNone/>
              <a:defRPr sz="1500"/>
            </a:lvl7pPr>
            <a:lvl8pPr marL="2400391" indent="0">
              <a:buNone/>
              <a:defRPr sz="1500"/>
            </a:lvl8pPr>
            <a:lvl9pPr marL="2743302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13" indent="0">
              <a:buNone/>
              <a:defRPr sz="1051"/>
            </a:lvl2pPr>
            <a:lvl3pPr marL="685827" indent="0">
              <a:buNone/>
              <a:defRPr sz="900"/>
            </a:lvl3pPr>
            <a:lvl4pPr marL="1028738" indent="0">
              <a:buNone/>
              <a:defRPr sz="750"/>
            </a:lvl4pPr>
            <a:lvl5pPr marL="1371653" indent="0">
              <a:buNone/>
              <a:defRPr sz="750"/>
            </a:lvl5pPr>
            <a:lvl6pPr marL="1714564" indent="0">
              <a:buNone/>
              <a:defRPr sz="750"/>
            </a:lvl6pPr>
            <a:lvl7pPr marL="2057478" indent="0">
              <a:buNone/>
              <a:defRPr sz="750"/>
            </a:lvl7pPr>
            <a:lvl8pPr marL="2400391" indent="0">
              <a:buNone/>
              <a:defRPr sz="750"/>
            </a:lvl8pPr>
            <a:lvl9pPr marL="2743302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948326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649119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8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71551B-8771-4709-894C-4DDA3D28F06C}" type="datetimeFigureOut">
              <a:rPr lang="it-IT" smtClean="0"/>
              <a:t>11/10/2021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11300188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8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A6A389-FA9A-473C-AD12-F0E03B2FE752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241016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27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6" indent="-171456" algn="l" defTabSz="685827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71" indent="-171456" algn="l" defTabSz="68582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857282" indent="-171456" algn="l" defTabSz="68582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95" indent="-171456" algn="l" defTabSz="68582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4pPr>
      <a:lvl5pPr marL="1543109" indent="-171456" algn="l" defTabSz="68582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5pPr>
      <a:lvl6pPr marL="1886020" indent="-171456" algn="l" defTabSz="68582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6pPr>
      <a:lvl7pPr marL="2228935" indent="-171456" algn="l" defTabSz="68582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7pPr>
      <a:lvl8pPr marL="2571845" indent="-171456" algn="l" defTabSz="68582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8pPr>
      <a:lvl9pPr marL="2914760" indent="-171456" algn="l" defTabSz="685827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4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27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1pPr>
      <a:lvl2pPr marL="342913" algn="l" defTabSz="685827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2pPr>
      <a:lvl3pPr marL="685827" algn="l" defTabSz="685827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3pPr>
      <a:lvl4pPr marL="1028738" algn="l" defTabSz="685827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4pPr>
      <a:lvl5pPr marL="1371653" algn="l" defTabSz="685827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5pPr>
      <a:lvl6pPr marL="1714564" algn="l" defTabSz="685827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6pPr>
      <a:lvl7pPr marL="2057478" algn="l" defTabSz="685827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7pPr>
      <a:lvl8pPr marL="2400391" algn="l" defTabSz="685827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8pPr>
      <a:lvl9pPr marL="2743302" algn="l" defTabSz="685827" rtl="0" eaLnBrk="1" latinLnBrk="0" hangingPunct="1">
        <a:defRPr sz="134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tif"/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ti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02CA0DA1-56AC-462E-B370-408B701AB22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7" y="322729"/>
            <a:ext cx="5915025" cy="8615209"/>
          </a:xfrm>
        </p:spPr>
        <p:txBody>
          <a:bodyPr>
            <a:normAutofit fontScale="62500" lnSpcReduction="20000"/>
          </a:bodyPr>
          <a:lstStyle/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  <a:tabLst>
                <a:tab pos="5911215" algn="l"/>
              </a:tabLst>
            </a:pPr>
            <a:r>
              <a:rPr lang="en-GB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                          </a:t>
            </a:r>
            <a:r>
              <a:rPr lang="en-GB" sz="19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flügers</a:t>
            </a:r>
            <a:r>
              <a:rPr lang="en-GB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9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rchiv</a:t>
            </a:r>
            <a:r>
              <a:rPr lang="en-GB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– European Journal of Physiology</a:t>
            </a: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  <a:tabLst>
                <a:tab pos="5911215" algn="l"/>
              </a:tabLst>
            </a:pPr>
            <a:endParaRPr lang="en-GB" sz="19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  <a:tabLst>
                <a:tab pos="5911215" algn="l"/>
              </a:tabLst>
            </a:pPr>
            <a:r>
              <a:rPr lang="en-GB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YNAMIC EXPRESSION OF HOMEOSTATIC ION CHANNELS IN DIFFERENTIATED CORTICAL ASTROCYTES IN VITRO</a:t>
            </a:r>
            <a:endParaRPr lang="en-GB" sz="1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  <a:tabLst>
                <a:tab pos="5911215" algn="l"/>
              </a:tabLst>
            </a:pPr>
            <a:r>
              <a:rPr lang="it-IT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</a:t>
            </a:r>
            <a:r>
              <a:rPr lang="it-IT" sz="1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ancesco</a:t>
            </a:r>
            <a:r>
              <a:rPr lang="it-IT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Formaggio*, Martina </a:t>
            </a:r>
            <a:r>
              <a:rPr lang="it-IT" sz="19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azzina</a:t>
            </a:r>
            <a:r>
              <a:rPr lang="it-IT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^, </a:t>
            </a:r>
            <a:r>
              <a:rPr lang="it-IT" sz="19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Ra</a:t>
            </a:r>
            <a:r>
              <a:rPr lang="it-IT" sz="19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ú</a:t>
            </a:r>
            <a:r>
              <a:rPr lang="it-IT" sz="19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l</a:t>
            </a:r>
            <a:r>
              <a:rPr lang="it-IT" sz="1800" dirty="0">
                <a:effectLst/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it-IT" sz="19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stévez</a:t>
            </a:r>
            <a:r>
              <a:rPr lang="it-IT" sz="1900" baseline="2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it-IT" sz="1900" baseline="20000" dirty="0">
                <a:solidFill>
                  <a:srgbClr val="000000"/>
                </a:solidFill>
                <a:effectLst/>
                <a:latin typeface="Segoe UI" panose="020B0502040204020203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¶</a:t>
            </a:r>
            <a:r>
              <a:rPr lang="it-IT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Marco Caprini* and Stefano Ferroni*</a:t>
            </a:r>
            <a:endParaRPr lang="en-GB" sz="1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endParaRPr lang="it-IT" sz="19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r>
              <a:rPr lang="en-GB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* Department of Pharmacy and Biotechnology, University of Bologna, Bologna, </a:t>
            </a:r>
            <a:r>
              <a:rPr lang="en-GB" sz="1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I</a:t>
            </a:r>
            <a:r>
              <a:rPr lang="en-GB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aly</a:t>
            </a:r>
            <a:endParaRPr lang="en-GB" sz="1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r>
              <a:rPr lang="fr-FR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+</a:t>
            </a:r>
            <a:r>
              <a:rPr lang="fr-FR" sz="1900" baseline="2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epartament de Ciències Fisiològiques, IDIBELL - Institute of Neurosciences,</a:t>
            </a:r>
            <a:r>
              <a:rPr lang="en-GB" sz="19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iversitat de Barcelona, Spain.</a:t>
            </a:r>
            <a:endParaRPr lang="en-GB" sz="1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r>
              <a:rPr lang="fr-FR" sz="19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¶</a:t>
            </a:r>
            <a:r>
              <a:rPr lang="fr-FR" sz="1900" baseline="2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s-ES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entro de Investigación Biomédica en Red sobre Enfermedades Raras (CIBERER), Instituto de Salud Carlos III, Spai</a:t>
            </a: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endParaRPr lang="es-ES" sz="19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r>
              <a:rPr lang="en-GB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ress for correspondence</a:t>
            </a:r>
            <a:r>
              <a:rPr lang="fr-FR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endParaRPr lang="en-GB" sz="1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r>
              <a:rPr lang="en-US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tefano Ferroni, Department of Pharmacy and Biotechnology, University of Bologna, Via San Donato 19/2, 40127 Bologna</a:t>
            </a:r>
            <a:endParaRPr lang="en-GB" sz="1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endParaRPr lang="en-US" sz="19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r>
              <a:rPr lang="en-US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mail: stefano.ferroni@unibo.it</a:t>
            </a:r>
            <a:endParaRPr lang="en-GB" sz="1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r>
              <a:rPr lang="en-US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hone: +39-0512095633</a:t>
            </a: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endParaRPr lang="en-US" sz="19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r>
              <a:rPr lang="en-US" sz="19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^ </a:t>
            </a:r>
            <a:r>
              <a:rPr lang="en-US" sz="1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sz="19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rrent address:</a:t>
            </a: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r>
              <a:rPr lang="en-US" sz="19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for Life Quality Studies, University of Bologna, Rimini, Italy</a:t>
            </a:r>
            <a:endParaRPr lang="en-GB" sz="19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endParaRPr lang="en-US" sz="19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endParaRPr lang="en-US" sz="19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endParaRPr lang="en-GB" sz="1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indent="0" algn="just">
              <a:lnSpc>
                <a:spcPct val="220000"/>
              </a:lnSpc>
              <a:spcBef>
                <a:spcPts val="0"/>
              </a:spcBef>
              <a:buNone/>
            </a:pPr>
            <a:endParaRPr lang="en-US" sz="19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092975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>
            <a:extLst>
              <a:ext uri="{FF2B5EF4-FFF2-40B4-BE49-F238E27FC236}">
                <a16:creationId xmlns:a16="http://schemas.microsoft.com/office/drawing/2014/main" id="{C687E407-F013-4B26-A877-108F3555345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40" t="6127" r="2630" b="3432"/>
          <a:stretch/>
        </p:blipFill>
        <p:spPr>
          <a:xfrm>
            <a:off x="3819742" y="3992964"/>
            <a:ext cx="2158114" cy="1684455"/>
          </a:xfrm>
          <a:prstGeom prst="rect">
            <a:avLst/>
          </a:prstGeom>
        </p:spPr>
      </p:pic>
      <p:pic>
        <p:nvPicPr>
          <p:cNvPr id="11" name="Immagine 10">
            <a:extLst>
              <a:ext uri="{FF2B5EF4-FFF2-40B4-BE49-F238E27FC236}">
                <a16:creationId xmlns:a16="http://schemas.microsoft.com/office/drawing/2014/main" id="{A93C5304-B44C-4EFC-BAEB-2EAD6A85339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1" t="4358" r="1806" b="3470"/>
          <a:stretch/>
        </p:blipFill>
        <p:spPr>
          <a:xfrm>
            <a:off x="3846797" y="2202030"/>
            <a:ext cx="2019736" cy="1602321"/>
          </a:xfrm>
          <a:prstGeom prst="rect">
            <a:avLst/>
          </a:prstGeom>
        </p:spPr>
      </p:pic>
      <p:graphicFrame>
        <p:nvGraphicFramePr>
          <p:cNvPr id="22" name="Tabella 22">
            <a:extLst>
              <a:ext uri="{FF2B5EF4-FFF2-40B4-BE49-F238E27FC236}">
                <a16:creationId xmlns:a16="http://schemas.microsoft.com/office/drawing/2014/main" id="{5182F6AF-CBF0-40CF-B801-F126CFA4E5F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3177710"/>
              </p:ext>
            </p:extLst>
          </p:nvPr>
        </p:nvGraphicFramePr>
        <p:xfrm>
          <a:off x="542292" y="6166935"/>
          <a:ext cx="5734683" cy="305897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048383">
                  <a:extLst>
                    <a:ext uri="{9D8B030D-6E8A-4147-A177-3AD203B41FA5}">
                      <a16:colId xmlns:a16="http://schemas.microsoft.com/office/drawing/2014/main" val="1294916243"/>
                    </a:ext>
                  </a:extLst>
                </a:gridCol>
                <a:gridCol w="1108390">
                  <a:extLst>
                    <a:ext uri="{9D8B030D-6E8A-4147-A177-3AD203B41FA5}">
                      <a16:colId xmlns:a16="http://schemas.microsoft.com/office/drawing/2014/main" val="2807750907"/>
                    </a:ext>
                  </a:extLst>
                </a:gridCol>
                <a:gridCol w="733714">
                  <a:extLst>
                    <a:ext uri="{9D8B030D-6E8A-4147-A177-3AD203B41FA5}">
                      <a16:colId xmlns:a16="http://schemas.microsoft.com/office/drawing/2014/main" val="2598576801"/>
                    </a:ext>
                  </a:extLst>
                </a:gridCol>
                <a:gridCol w="1185346">
                  <a:extLst>
                    <a:ext uri="{9D8B030D-6E8A-4147-A177-3AD203B41FA5}">
                      <a16:colId xmlns:a16="http://schemas.microsoft.com/office/drawing/2014/main" val="3672892431"/>
                    </a:ext>
                  </a:extLst>
                </a:gridCol>
                <a:gridCol w="731797">
                  <a:extLst>
                    <a:ext uri="{9D8B030D-6E8A-4147-A177-3AD203B41FA5}">
                      <a16:colId xmlns:a16="http://schemas.microsoft.com/office/drawing/2014/main" val="4196690602"/>
                    </a:ext>
                  </a:extLst>
                </a:gridCol>
                <a:gridCol w="927053">
                  <a:extLst>
                    <a:ext uri="{9D8B030D-6E8A-4147-A177-3AD203B41FA5}">
                      <a16:colId xmlns:a16="http://schemas.microsoft.com/office/drawing/2014/main" val="3874398479"/>
                    </a:ext>
                  </a:extLst>
                </a:gridCol>
              </a:tblGrid>
              <a:tr h="498646">
                <a:tc>
                  <a:txBody>
                    <a:bodyPr/>
                    <a:lstStyle/>
                    <a:p>
                      <a:pPr algn="ctr"/>
                      <a:r>
                        <a:rPr lang="it-IT" sz="1100" b="0" dirty="0"/>
                        <a:t>Group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it-IT" sz="1100" b="0" i="0" u="none" strike="noStrike" dirty="0">
                          <a:effectLst/>
                          <a:latin typeface="+mn-lt"/>
                        </a:rPr>
                        <a:t>D'Agostino &amp; Pearson test</a:t>
                      </a:r>
                    </a:p>
                  </a:txBody>
                  <a:tcPr marL="3810" marR="3810" marT="3810" marB="0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b="0" dirty="0"/>
                        <a:t>Fitting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b="0" dirty="0"/>
                        <a:t>Fitting Method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dirty="0"/>
                        <a:t>R </a:t>
                      </a:r>
                      <a:r>
                        <a:rPr lang="it-IT" sz="1100" b="0" dirty="0" err="1"/>
                        <a:t>squared</a:t>
                      </a:r>
                      <a:endParaRPr lang="it-IT" sz="1100" b="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b="0" dirty="0"/>
                        <a:t>St. Dev. </a:t>
                      </a:r>
                      <a:r>
                        <a:rPr lang="it-IT" sz="1100" b="0" dirty="0" err="1"/>
                        <a:t>Residuals</a:t>
                      </a:r>
                      <a:endParaRPr lang="it-IT" sz="1100" b="0" dirty="0"/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2155501775"/>
                  </a:ext>
                </a:extLst>
              </a:tr>
              <a:tr h="358003">
                <a:tc>
                  <a:txBody>
                    <a:bodyPr/>
                    <a:lstStyle/>
                    <a:p>
                      <a:pPr algn="ctr"/>
                      <a:r>
                        <a:rPr lang="it-IT" sz="1100" b="1" dirty="0" err="1"/>
                        <a:t>Ctrl</a:t>
                      </a:r>
                      <a:r>
                        <a:rPr lang="it-IT" sz="1100" b="1" dirty="0"/>
                        <a:t>  5-7 DO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err="1"/>
                        <a:t>Passed</a:t>
                      </a:r>
                      <a:r>
                        <a:rPr lang="it-IT" sz="1100" dirty="0"/>
                        <a:t> (p=0.1631)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err="1"/>
                        <a:t>Gaussian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Robust</a:t>
                      </a:r>
                      <a:r>
                        <a:rPr lang="it-IT" sz="1100" dirty="0"/>
                        <a:t> </a:t>
                      </a:r>
                      <a:r>
                        <a:rPr lang="it-IT" sz="1100" dirty="0" err="1"/>
                        <a:t>regression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/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0.9391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3520558512"/>
                  </a:ext>
                </a:extLst>
              </a:tr>
              <a:tr h="358003">
                <a:tc>
                  <a:txBody>
                    <a:bodyPr/>
                    <a:lstStyle/>
                    <a:p>
                      <a:pPr algn="ctr"/>
                      <a:r>
                        <a:rPr lang="it-IT" sz="1100" b="1" dirty="0"/>
                        <a:t>G5 5-7 DO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Not </a:t>
                      </a:r>
                      <a:r>
                        <a:rPr lang="it-IT" sz="1100" dirty="0" err="1"/>
                        <a:t>passed</a:t>
                      </a:r>
                      <a:r>
                        <a:rPr lang="it-IT" sz="1100" dirty="0"/>
                        <a:t> (p=0.0017)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Bimodal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Least-squares</a:t>
                      </a:r>
                      <a:r>
                        <a:rPr lang="it-IT" sz="1100" dirty="0"/>
                        <a:t> </a:t>
                      </a:r>
                      <a:r>
                        <a:rPr lang="it-IT" sz="1100" dirty="0" err="1"/>
                        <a:t>regression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0.7246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0.8772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2018194962"/>
                  </a:ext>
                </a:extLst>
              </a:tr>
              <a:tr h="358003">
                <a:tc>
                  <a:txBody>
                    <a:bodyPr/>
                    <a:lstStyle/>
                    <a:p>
                      <a:pPr algn="ctr"/>
                      <a:r>
                        <a:rPr lang="it-IT" sz="1100" b="1" dirty="0" err="1"/>
                        <a:t>Ctrl</a:t>
                      </a:r>
                      <a:r>
                        <a:rPr lang="it-IT" sz="1100" b="1" dirty="0"/>
                        <a:t> 8-11 DO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Passed</a:t>
                      </a:r>
                      <a:r>
                        <a:rPr lang="it-IT" sz="1100" dirty="0"/>
                        <a:t> (p=0.4239)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err="1"/>
                        <a:t>Gaussian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Robust</a:t>
                      </a:r>
                      <a:r>
                        <a:rPr lang="it-IT" sz="1100" dirty="0"/>
                        <a:t> </a:t>
                      </a:r>
                      <a:r>
                        <a:rPr lang="it-IT" sz="1100" dirty="0" err="1"/>
                        <a:t>regression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/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1.596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2403423863"/>
                  </a:ext>
                </a:extLst>
              </a:tr>
              <a:tr h="358003">
                <a:tc>
                  <a:txBody>
                    <a:bodyPr/>
                    <a:lstStyle/>
                    <a:p>
                      <a:pPr algn="ctr"/>
                      <a:r>
                        <a:rPr lang="it-IT" sz="1100" b="1" dirty="0"/>
                        <a:t>G5 8-11 DO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/>
                        <a:t>Not </a:t>
                      </a:r>
                      <a:r>
                        <a:rPr lang="it-IT" sz="1100" dirty="0" err="1"/>
                        <a:t>passed</a:t>
                      </a:r>
                      <a:r>
                        <a:rPr lang="it-IT" sz="1100" dirty="0"/>
                        <a:t> (p=0.0166)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err="1"/>
                        <a:t>Bimodal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Least-squares</a:t>
                      </a:r>
                      <a:r>
                        <a:rPr lang="it-IT" sz="1100" dirty="0"/>
                        <a:t> </a:t>
                      </a:r>
                      <a:r>
                        <a:rPr lang="it-IT" sz="1100" dirty="0" err="1"/>
                        <a:t>regression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0.7059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1.719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1133644050"/>
                  </a:ext>
                </a:extLst>
              </a:tr>
              <a:tr h="358003">
                <a:tc>
                  <a:txBody>
                    <a:bodyPr/>
                    <a:lstStyle/>
                    <a:p>
                      <a:pPr algn="ctr"/>
                      <a:r>
                        <a:rPr lang="it-IT" sz="1100" b="1" dirty="0" err="1"/>
                        <a:t>Ctrl</a:t>
                      </a:r>
                      <a:r>
                        <a:rPr lang="it-IT" sz="1100" b="1" dirty="0"/>
                        <a:t> 12-16 DO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Passed</a:t>
                      </a:r>
                      <a:r>
                        <a:rPr lang="it-IT" sz="1100" dirty="0"/>
                        <a:t> (p=0.8050)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err="1"/>
                        <a:t>Gaussian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Least-squares</a:t>
                      </a:r>
                      <a:r>
                        <a:rPr lang="it-IT" sz="1100" dirty="0"/>
                        <a:t> </a:t>
                      </a:r>
                      <a:r>
                        <a:rPr lang="it-IT" sz="1100" dirty="0" err="1"/>
                        <a:t>regression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0.7828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1.222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1968240267"/>
                  </a:ext>
                </a:extLst>
              </a:tr>
              <a:tr h="358003">
                <a:tc>
                  <a:txBody>
                    <a:bodyPr/>
                    <a:lstStyle/>
                    <a:p>
                      <a:pPr algn="ctr"/>
                      <a:r>
                        <a:rPr lang="it-IT" sz="1100" b="1" dirty="0"/>
                        <a:t>G5 12-16 DOT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/>
                        <a:t>Not </a:t>
                      </a:r>
                      <a:r>
                        <a:rPr lang="it-IT" sz="1100" dirty="0" err="1"/>
                        <a:t>passed</a:t>
                      </a:r>
                      <a:r>
                        <a:rPr lang="it-IT" sz="1100" dirty="0"/>
                        <a:t> (p&lt;0.0001)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Bimodal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err="1"/>
                        <a:t>Least-squares</a:t>
                      </a:r>
                      <a:r>
                        <a:rPr lang="it-IT" sz="1100" dirty="0"/>
                        <a:t> </a:t>
                      </a:r>
                      <a:r>
                        <a:rPr lang="it-IT" sz="1100" dirty="0" err="1"/>
                        <a:t>regression</a:t>
                      </a:r>
                      <a:endParaRPr lang="it-IT" sz="1100" dirty="0"/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0.9402</a:t>
                      </a:r>
                    </a:p>
                  </a:txBody>
                  <a:tcPr marT="45721" marB="45721"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/>
                        <a:t>1.022</a:t>
                      </a:r>
                    </a:p>
                  </a:txBody>
                  <a:tcPr marT="45721" marB="45721" anchor="ctr"/>
                </a:tc>
                <a:extLst>
                  <a:ext uri="{0D108BD9-81ED-4DB2-BD59-A6C34878D82A}">
                    <a16:rowId xmlns:a16="http://schemas.microsoft.com/office/drawing/2014/main" val="1563597018"/>
                  </a:ext>
                </a:extLst>
              </a:tr>
            </a:tbl>
          </a:graphicData>
        </a:graphic>
      </p:graphicFrame>
      <p:sp>
        <p:nvSpPr>
          <p:cNvPr id="24" name="CasellaDiTesto 23">
            <a:extLst>
              <a:ext uri="{FF2B5EF4-FFF2-40B4-BE49-F238E27FC236}">
                <a16:creationId xmlns:a16="http://schemas.microsoft.com/office/drawing/2014/main" id="{464FD054-9980-4AC1-AE08-E8B7757B831C}"/>
              </a:ext>
            </a:extLst>
          </p:cNvPr>
          <p:cNvSpPr txBox="1"/>
          <p:nvPr/>
        </p:nvSpPr>
        <p:spPr>
          <a:xfrm>
            <a:off x="3038769" y="5836934"/>
            <a:ext cx="780514" cy="3079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1" b="1" dirty="0" err="1"/>
              <a:t>Table</a:t>
            </a:r>
            <a:r>
              <a:rPr lang="it-IT" sz="1401" b="1" dirty="0"/>
              <a:t> 4 </a:t>
            </a:r>
          </a:p>
        </p:txBody>
      </p:sp>
      <p:pic>
        <p:nvPicPr>
          <p:cNvPr id="3" name="Immagine 2">
            <a:extLst>
              <a:ext uri="{FF2B5EF4-FFF2-40B4-BE49-F238E27FC236}">
                <a16:creationId xmlns:a16="http://schemas.microsoft.com/office/drawing/2014/main" id="{E75DC07C-57F5-4EB1-BD4D-B1AA6919249B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292" y="365506"/>
            <a:ext cx="2351789" cy="1684455"/>
          </a:xfrm>
          <a:prstGeom prst="rect">
            <a:avLst/>
          </a:prstGeom>
        </p:spPr>
      </p:pic>
      <p:pic>
        <p:nvPicPr>
          <p:cNvPr id="6" name="Immagine 5">
            <a:extLst>
              <a:ext uri="{FF2B5EF4-FFF2-40B4-BE49-F238E27FC236}">
                <a16:creationId xmlns:a16="http://schemas.microsoft.com/office/drawing/2014/main" id="{1F40EE6A-916C-4A4F-9B7C-B9A4B0561390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97575" y="401601"/>
            <a:ext cx="2111822" cy="1684456"/>
          </a:xfrm>
          <a:prstGeom prst="rect">
            <a:avLst/>
          </a:prstGeom>
        </p:spPr>
      </p:pic>
      <p:pic>
        <p:nvPicPr>
          <p:cNvPr id="12" name="Immagine 11">
            <a:extLst>
              <a:ext uri="{FF2B5EF4-FFF2-40B4-BE49-F238E27FC236}">
                <a16:creationId xmlns:a16="http://schemas.microsoft.com/office/drawing/2014/main" id="{6C8DA533-0C65-46A6-8806-6751C0E41AA5}"/>
              </a:ext>
            </a:extLst>
          </p:cNvPr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71292" y="4001938"/>
            <a:ext cx="2351789" cy="1684455"/>
          </a:xfrm>
          <a:prstGeom prst="rect">
            <a:avLst/>
          </a:prstGeom>
        </p:spPr>
      </p:pic>
      <p:sp>
        <p:nvSpPr>
          <p:cNvPr id="15" name="CasellaDiTesto 14">
            <a:extLst>
              <a:ext uri="{FF2B5EF4-FFF2-40B4-BE49-F238E27FC236}">
                <a16:creationId xmlns:a16="http://schemas.microsoft.com/office/drawing/2014/main" id="{B389EA2B-DEE2-4922-97D6-2B29FCFB22A9}"/>
              </a:ext>
            </a:extLst>
          </p:cNvPr>
          <p:cNvSpPr txBox="1"/>
          <p:nvPr/>
        </p:nvSpPr>
        <p:spPr>
          <a:xfrm>
            <a:off x="1646954" y="456958"/>
            <a:ext cx="10455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CTRL 5-7 DOT</a:t>
            </a:r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19DF8B4D-6197-4156-ABF5-B543F536BA77}"/>
              </a:ext>
            </a:extLst>
          </p:cNvPr>
          <p:cNvSpPr txBox="1"/>
          <p:nvPr/>
        </p:nvSpPr>
        <p:spPr>
          <a:xfrm>
            <a:off x="1646840" y="4014411"/>
            <a:ext cx="12001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CTRL 12-16 DOT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7DDCCA0D-96AD-4845-9F30-0E7734A8F26F}"/>
              </a:ext>
            </a:extLst>
          </p:cNvPr>
          <p:cNvSpPr txBox="1"/>
          <p:nvPr/>
        </p:nvSpPr>
        <p:spPr>
          <a:xfrm>
            <a:off x="4511451" y="457440"/>
            <a:ext cx="91945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G5 5-7 DOT</a:t>
            </a:r>
          </a:p>
        </p:txBody>
      </p: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C621811-D1EB-4C58-B909-8C2430826C8B}"/>
              </a:ext>
            </a:extLst>
          </p:cNvPr>
          <p:cNvSpPr txBox="1"/>
          <p:nvPr/>
        </p:nvSpPr>
        <p:spPr>
          <a:xfrm>
            <a:off x="4510591" y="4014411"/>
            <a:ext cx="10192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G5 12-16 DOT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66937500-785A-4CD0-92CC-AD2A9834D3E7}"/>
              </a:ext>
            </a:extLst>
          </p:cNvPr>
          <p:cNvSpPr txBox="1"/>
          <p:nvPr/>
        </p:nvSpPr>
        <p:spPr>
          <a:xfrm>
            <a:off x="4512921" y="2140419"/>
            <a:ext cx="105309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G5 8-11 DOT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04865E4B-C06C-40D9-8116-74101F34BF07}"/>
              </a:ext>
            </a:extLst>
          </p:cNvPr>
          <p:cNvSpPr txBox="1"/>
          <p:nvPr/>
        </p:nvSpPr>
        <p:spPr>
          <a:xfrm>
            <a:off x="756144" y="113604"/>
            <a:ext cx="7243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5" name="CasellaDiTesto 24">
            <a:extLst>
              <a:ext uri="{FF2B5EF4-FFF2-40B4-BE49-F238E27FC236}">
                <a16:creationId xmlns:a16="http://schemas.microsoft.com/office/drawing/2014/main" id="{FCFE4FE3-5494-4EE8-8294-A2D0063E4DE2}"/>
              </a:ext>
            </a:extLst>
          </p:cNvPr>
          <p:cNvSpPr txBox="1"/>
          <p:nvPr/>
        </p:nvSpPr>
        <p:spPr>
          <a:xfrm>
            <a:off x="287289" y="9343588"/>
            <a:ext cx="6283422" cy="267765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1 - Frequency distributions of resting membrane potentials in untreated and G5-treated primary cortical astrocytes</a:t>
            </a:r>
          </a:p>
          <a:p>
            <a:pPr algn="just"/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Frequency histograms of RMP values of untreated (ctrl) and G5-treated astrocytes </a:t>
            </a:r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t the different windows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days of treatment (DOT). A bin of 5 was used for ctrl and 3 for G5. The table shows the analysis performed on RMP data using the D’Agostino &amp; Pearson test to assess normal distribution consistency (table 4). Fitting was performed with gaussian or bimodal distributions. Least-square regression was the first choice unless very low goodness of fit was achieved due to possible presence of outliers or inconsistent fitting (in this case a robust regression was performed). R-squared and the standard deviation of residuals is shown for the least-squares regression, whereas for robust regression the standard deviations of residuals was computed. The mean RMP of untreated astrocytes was -57 mV at 5-7 DOT, -52 mV at 8-11 DOT and -40 mV at 12-16 DOT. The RMP frequencies of G5-treated astrocytes were fitted to a binomial distribution with peaks at -75 mV and -43 mV at 5-7 DOT, -67 mV and -44 mV at 8-11 DOT  and -73 mV and -42 mV at 12-16 DOT.</a:t>
            </a:r>
            <a:endParaRPr lang="it-IT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Immagine 22">
            <a:extLst>
              <a:ext uri="{FF2B5EF4-FFF2-40B4-BE49-F238E27FC236}">
                <a16:creationId xmlns:a16="http://schemas.microsoft.com/office/drawing/2014/main" id="{A3B5E9BF-F880-4A4A-AE91-8687B998A3B0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0" t="5694" r="3278" b="3601"/>
          <a:stretch/>
        </p:blipFill>
        <p:spPr>
          <a:xfrm>
            <a:off x="1008631" y="2132921"/>
            <a:ext cx="2142884" cy="1710000"/>
          </a:xfrm>
          <a:prstGeom prst="rect">
            <a:avLst/>
          </a:prstGeom>
        </p:spPr>
      </p:pic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71C4D97E-87CA-4D21-8D8D-CE4507E1B04F}"/>
              </a:ext>
            </a:extLst>
          </p:cNvPr>
          <p:cNvSpPr txBox="1"/>
          <p:nvPr/>
        </p:nvSpPr>
        <p:spPr>
          <a:xfrm>
            <a:off x="1642829" y="2140788"/>
            <a:ext cx="1143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000" b="1" dirty="0">
                <a:latin typeface="Arial" panose="020B0604020202020204" pitchFamily="34" charset="0"/>
                <a:cs typeface="Arial" panose="020B0604020202020204" pitchFamily="34" charset="0"/>
              </a:rPr>
              <a:t>CTRL 8-11 DOT</a:t>
            </a:r>
          </a:p>
        </p:txBody>
      </p:sp>
    </p:spTree>
    <p:extLst>
      <p:ext uri="{BB962C8B-B14F-4D97-AF65-F5344CB8AC3E}">
        <p14:creationId xmlns:p14="http://schemas.microsoft.com/office/powerpoint/2010/main" val="34418383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6B6444B1-3227-4647-8CF0-554FBA4AE90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34" t="7673" r="6130" b="5295"/>
          <a:stretch/>
        </p:blipFill>
        <p:spPr>
          <a:xfrm>
            <a:off x="1017639" y="923479"/>
            <a:ext cx="4822722" cy="3449417"/>
          </a:xfrm>
          <a:prstGeom prst="rect">
            <a:avLst/>
          </a:prstGeom>
        </p:spPr>
      </p:pic>
      <p:sp>
        <p:nvSpPr>
          <p:cNvPr id="7" name="Text Box 40">
            <a:extLst>
              <a:ext uri="{FF2B5EF4-FFF2-40B4-BE49-F238E27FC236}">
                <a16:creationId xmlns:a16="http://schemas.microsoft.com/office/drawing/2014/main" id="{F85D5B86-E60C-4F56-A5ED-B222F02F53B6}"/>
              </a:ext>
            </a:extLst>
          </p:cNvPr>
          <p:cNvSpPr txBox="1">
            <a:spLocks noChangeArrowheads="1"/>
          </p:cNvSpPr>
          <p:nvPr/>
        </p:nvSpPr>
        <p:spPr bwMode="auto">
          <a:xfrm rot="16200000">
            <a:off x="2881858" y="1327372"/>
            <a:ext cx="890964" cy="239477"/>
          </a:xfrm>
          <a:prstGeom prst="rect">
            <a:avLst/>
          </a:prstGeom>
          <a:noFill/>
          <a:ln>
            <a:noFill/>
          </a:ln>
        </p:spPr>
        <p:txBody>
          <a:bodyPr lIns="6844" tIns="6844" rIns="6844" bIns="6844"/>
          <a:lstStyle>
            <a:lvl1pPr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8175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8175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8175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8175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defRPr/>
            </a:pPr>
            <a:r>
              <a:rPr lang="de-DE" altLang="it-IT" sz="1400" b="1" dirty="0">
                <a:solidFill>
                  <a:srgbClr val="000000"/>
                </a:solidFill>
                <a:latin typeface="Arial" panose="020B0604020202020204" pitchFamily="34" charset="0"/>
              </a:rPr>
              <a:t>I (pA/pF)</a:t>
            </a:r>
            <a:endParaRPr lang="it-IT" altLang="it-IT" sz="1400" b="1" dirty="0">
              <a:latin typeface="Arial" panose="020B0604020202020204" pitchFamily="34" charset="0"/>
            </a:endParaRPr>
          </a:p>
        </p:txBody>
      </p:sp>
      <p:sp>
        <p:nvSpPr>
          <p:cNvPr id="8" name="Text Box 40">
            <a:extLst>
              <a:ext uri="{FF2B5EF4-FFF2-40B4-BE49-F238E27FC236}">
                <a16:creationId xmlns:a16="http://schemas.microsoft.com/office/drawing/2014/main" id="{533A0E77-29F9-4C97-8753-7E9330E1AEE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57534" y="3775609"/>
            <a:ext cx="822268" cy="317051"/>
          </a:xfrm>
          <a:prstGeom prst="rect">
            <a:avLst/>
          </a:prstGeom>
          <a:noFill/>
          <a:ln>
            <a:noFill/>
          </a:ln>
        </p:spPr>
        <p:txBody>
          <a:bodyPr lIns="6844" tIns="6844" rIns="6844" bIns="6844"/>
          <a:lstStyle>
            <a:lvl1pPr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 defTabSz="817563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8175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8175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8175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817563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defRPr/>
            </a:pPr>
            <a:r>
              <a:rPr lang="de-DE" altLang="it-IT" sz="1400" b="1" dirty="0">
                <a:solidFill>
                  <a:srgbClr val="000000"/>
                </a:solidFill>
                <a:latin typeface="Arial" panose="020B0604020202020204" pitchFamily="34" charset="0"/>
              </a:rPr>
              <a:t> V (mV)</a:t>
            </a:r>
            <a:endParaRPr lang="it-IT" altLang="it-IT" sz="1400" b="1" dirty="0">
              <a:latin typeface="Arial" panose="020B0604020202020204" pitchFamily="34" charset="0"/>
            </a:endParaRPr>
          </a:p>
        </p:txBody>
      </p:sp>
      <p:sp>
        <p:nvSpPr>
          <p:cNvPr id="6" name="CasellaDiTesto 7">
            <a:extLst>
              <a:ext uri="{FF2B5EF4-FFF2-40B4-BE49-F238E27FC236}">
                <a16:creationId xmlns:a16="http://schemas.microsoft.com/office/drawing/2014/main" id="{ABA31724-F0AE-4EAB-8288-0B8BF9AC82CA}"/>
              </a:ext>
            </a:extLst>
          </p:cNvPr>
          <p:cNvSpPr txBox="1"/>
          <p:nvPr/>
        </p:nvSpPr>
        <p:spPr>
          <a:xfrm>
            <a:off x="335598" y="5556885"/>
            <a:ext cx="6186805" cy="146232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2 - Time-dependent effect of G5 treatment on whole-cell membrane conductance of primary cortical astrocytes</a:t>
            </a:r>
            <a:endParaRPr lang="en-GB" sz="1200" b="1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</a:pP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urrent-voltage relationship (I-V) of mean densities of steady-state currents elicited from a holding potential of -60 mV with a family of voltage steps (400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ms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 at the indicated potentials in primary astrocytes treated for 5-7 days (5-7 DOT) with G5 (black, n=12) and 12-16 DOT G5 astrocytes (red, n=11). * p&lt;0.05, ** p&lt;0.01, *** p&lt;0.001 compared to 5-7 DOT G5 astrocytes with unpaired Student’s t-test. 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5448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CasellaDiTesto 1">
            <a:extLst>
              <a:ext uri="{FF2B5EF4-FFF2-40B4-BE49-F238E27FC236}">
                <a16:creationId xmlns:a16="http://schemas.microsoft.com/office/drawing/2014/main" id="{7EEACA25-A324-4407-94F2-10F50F4487E3}"/>
              </a:ext>
            </a:extLst>
          </p:cNvPr>
          <p:cNvSpPr txBox="1"/>
          <p:nvPr/>
        </p:nvSpPr>
        <p:spPr>
          <a:xfrm>
            <a:off x="311785" y="5585107"/>
            <a:ext cx="6234430" cy="10670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3 - Expression of ClC-2 protein in primary cortical astrocytes 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untreated </a:t>
            </a: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treated for 5-7  days with G5</a:t>
            </a:r>
            <a:endParaRPr lang="en-GB" sz="12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</a:pP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Representative immunoblot of ClC-2 monomer from total lysate of untreated (ctrl) and astrocytes treated for 5-7 days (5-7 DOT) with G5. B) Densitometric analysis (n=3) of the immunoblot signals. Beta actin was used to normalize the immunoreactive band of interest.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2" name="Gruppo 1">
            <a:extLst>
              <a:ext uri="{FF2B5EF4-FFF2-40B4-BE49-F238E27FC236}">
                <a16:creationId xmlns:a16="http://schemas.microsoft.com/office/drawing/2014/main" id="{ED07E8CC-2961-4688-8976-299527810392}"/>
              </a:ext>
            </a:extLst>
          </p:cNvPr>
          <p:cNvGrpSpPr/>
          <p:nvPr/>
        </p:nvGrpSpPr>
        <p:grpSpPr>
          <a:xfrm>
            <a:off x="1223867" y="1643658"/>
            <a:ext cx="4600651" cy="3139634"/>
            <a:chOff x="1223867" y="1643658"/>
            <a:chExt cx="4600651" cy="3139634"/>
          </a:xfrm>
        </p:grpSpPr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50721C16-9CD5-4288-8B54-9E00760F40B9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88454" y="1851116"/>
              <a:ext cx="2036064" cy="2932176"/>
            </a:xfrm>
            <a:prstGeom prst="rect">
              <a:avLst/>
            </a:prstGeom>
          </p:spPr>
        </p:pic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05226148-C724-41D1-8783-E8123F3D903F}"/>
                </a:ext>
              </a:extLst>
            </p:cNvPr>
            <p:cNvSpPr txBox="1"/>
            <p:nvPr/>
          </p:nvSpPr>
          <p:spPr>
            <a:xfrm>
              <a:off x="2243629" y="3358144"/>
              <a:ext cx="9261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lC-2 IB</a:t>
              </a:r>
            </a:p>
          </p:txBody>
        </p:sp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0E80E644-2374-41D8-AC96-5E20648B6D93}"/>
                </a:ext>
              </a:extLst>
            </p:cNvPr>
            <p:cNvSpPr txBox="1"/>
            <p:nvPr/>
          </p:nvSpPr>
          <p:spPr>
            <a:xfrm>
              <a:off x="1463406" y="3035614"/>
              <a:ext cx="64472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62B40FC4-1895-4DBF-BAAB-0F19D8034CF7}"/>
                </a:ext>
              </a:extLst>
            </p:cNvPr>
            <p:cNvSpPr txBox="1"/>
            <p:nvPr/>
          </p:nvSpPr>
          <p:spPr>
            <a:xfrm>
              <a:off x="2243629" y="4461702"/>
              <a:ext cx="92611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IB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A34046C9-26A9-477B-9845-B7029FD673B7}"/>
                </a:ext>
              </a:extLst>
            </p:cNvPr>
            <p:cNvSpPr txBox="1"/>
            <p:nvPr/>
          </p:nvSpPr>
          <p:spPr>
            <a:xfrm rot="18397049">
              <a:off x="2512835" y="2127896"/>
              <a:ext cx="112117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G5 5-7 DOT</a:t>
              </a:r>
            </a:p>
          </p:txBody>
        </p:sp>
        <p:cxnSp>
          <p:nvCxnSpPr>
            <p:cNvPr id="8" name="Connettore diritto 36">
              <a:extLst>
                <a:ext uri="{FF2B5EF4-FFF2-40B4-BE49-F238E27FC236}">
                  <a16:creationId xmlns:a16="http://schemas.microsoft.com/office/drawing/2014/main" id="{26B47567-1248-4684-8689-18F34BA54AB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709834" y="3275844"/>
              <a:ext cx="25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3D55D206-B1CD-48F9-B782-D325E71ACF12}"/>
                </a:ext>
              </a:extLst>
            </p:cNvPr>
            <p:cNvSpPr txBox="1"/>
            <p:nvPr/>
          </p:nvSpPr>
          <p:spPr>
            <a:xfrm rot="18470945">
              <a:off x="1927767" y="2107310"/>
              <a:ext cx="113934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 5-7 DOT</a:t>
              </a:r>
            </a:p>
          </p:txBody>
        </p:sp>
        <p:cxnSp>
          <p:nvCxnSpPr>
            <p:cNvPr id="11" name="Connettore diritto 36">
              <a:extLst>
                <a:ext uri="{FF2B5EF4-FFF2-40B4-BE49-F238E27FC236}">
                  <a16:creationId xmlns:a16="http://schemas.microsoft.com/office/drawing/2014/main" id="{817E667F-A40D-40D0-B52E-010403B97510}"/>
                </a:ext>
              </a:extLst>
            </p:cNvPr>
            <p:cNvCxnSpPr>
              <a:cxnSpLocks/>
            </p:cNvCxnSpPr>
            <p:nvPr/>
          </p:nvCxnSpPr>
          <p:spPr>
            <a:xfrm>
              <a:off x="1719670" y="2970984"/>
              <a:ext cx="25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FADD714F-EE4B-4C2E-ADE3-65AF69A431AB}"/>
                </a:ext>
              </a:extLst>
            </p:cNvPr>
            <p:cNvSpPr txBox="1"/>
            <p:nvPr/>
          </p:nvSpPr>
          <p:spPr>
            <a:xfrm>
              <a:off x="1397626" y="2728865"/>
              <a:ext cx="67719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100 </a:t>
              </a:r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7" name="Immagine 16">
              <a:extLst>
                <a:ext uri="{FF2B5EF4-FFF2-40B4-BE49-F238E27FC236}">
                  <a16:creationId xmlns:a16="http://schemas.microsoft.com/office/drawing/2014/main" id="{F3CDB444-0E02-4A96-A977-D692390D31D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90965" y="3734165"/>
              <a:ext cx="1071128" cy="745221"/>
            </a:xfrm>
            <a:prstGeom prst="rect">
              <a:avLst/>
            </a:prstGeom>
          </p:spPr>
        </p:pic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2E58EB28-740C-4E8A-BB69-4BF3398A141F}"/>
                </a:ext>
              </a:extLst>
            </p:cNvPr>
            <p:cNvSpPr txBox="1"/>
            <p:nvPr/>
          </p:nvSpPr>
          <p:spPr>
            <a:xfrm>
              <a:off x="1485186" y="4044517"/>
              <a:ext cx="6229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it-IT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it-IT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9" name="Connettore diritto 36">
              <a:extLst>
                <a:ext uri="{FF2B5EF4-FFF2-40B4-BE49-F238E27FC236}">
                  <a16:creationId xmlns:a16="http://schemas.microsoft.com/office/drawing/2014/main" id="{AACB62FE-085B-4808-9EA7-0180CEDAC524}"/>
                </a:ext>
              </a:extLst>
            </p:cNvPr>
            <p:cNvCxnSpPr>
              <a:cxnSpLocks/>
            </p:cNvCxnSpPr>
            <p:nvPr/>
          </p:nvCxnSpPr>
          <p:spPr>
            <a:xfrm>
              <a:off x="1748596" y="4290738"/>
              <a:ext cx="25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" name="CasellaDiTesto 32">
              <a:extLst>
                <a:ext uri="{FF2B5EF4-FFF2-40B4-BE49-F238E27FC236}">
                  <a16:creationId xmlns:a16="http://schemas.microsoft.com/office/drawing/2014/main" id="{E6D99AC4-C41B-4510-84C4-30444CB7775D}"/>
                </a:ext>
              </a:extLst>
            </p:cNvPr>
            <p:cNvSpPr txBox="1"/>
            <p:nvPr/>
          </p:nvSpPr>
          <p:spPr>
            <a:xfrm>
              <a:off x="1223867" y="1650051"/>
              <a:ext cx="29778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4" name="CasellaDiTesto 32">
              <a:extLst>
                <a:ext uri="{FF2B5EF4-FFF2-40B4-BE49-F238E27FC236}">
                  <a16:creationId xmlns:a16="http://schemas.microsoft.com/office/drawing/2014/main" id="{5E14B72C-7CDF-48ED-96EB-2D7409B4A234}"/>
                </a:ext>
              </a:extLst>
            </p:cNvPr>
            <p:cNvSpPr txBox="1"/>
            <p:nvPr/>
          </p:nvSpPr>
          <p:spPr>
            <a:xfrm>
              <a:off x="3613248" y="1643658"/>
              <a:ext cx="29778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20" name="Immagine 19">
              <a:extLst>
                <a:ext uri="{FF2B5EF4-FFF2-40B4-BE49-F238E27FC236}">
                  <a16:creationId xmlns:a16="http://schemas.microsoft.com/office/drawing/2014/main" id="{949FE31C-9CBC-4985-A521-B1B7234BB2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154" b="11484"/>
            <a:stretch/>
          </p:blipFill>
          <p:spPr>
            <a:xfrm>
              <a:off x="2098950" y="2743199"/>
              <a:ext cx="1028752" cy="614945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5121339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FD963706-16FF-4BC2-934E-9E15AD254016}"/>
              </a:ext>
            </a:extLst>
          </p:cNvPr>
          <p:cNvGrpSpPr/>
          <p:nvPr/>
        </p:nvGrpSpPr>
        <p:grpSpPr>
          <a:xfrm>
            <a:off x="523190" y="1504218"/>
            <a:ext cx="5574825" cy="3770807"/>
            <a:chOff x="523190" y="1504218"/>
            <a:chExt cx="5574825" cy="3770807"/>
          </a:xfrm>
        </p:grpSpPr>
        <p:pic>
          <p:nvPicPr>
            <p:cNvPr id="16" name="Immagine 15">
              <a:extLst>
                <a:ext uri="{FF2B5EF4-FFF2-40B4-BE49-F238E27FC236}">
                  <a16:creationId xmlns:a16="http://schemas.microsoft.com/office/drawing/2014/main" id="{DE6633CE-A284-49C4-9F13-728C32A845A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832939" y="1982232"/>
              <a:ext cx="2265076" cy="3291954"/>
            </a:xfrm>
            <a:prstGeom prst="rect">
              <a:avLst/>
            </a:prstGeom>
          </p:spPr>
        </p:pic>
        <p:pic>
          <p:nvPicPr>
            <p:cNvPr id="3" name="Immagine 2">
              <a:extLst>
                <a:ext uri="{FF2B5EF4-FFF2-40B4-BE49-F238E27FC236}">
                  <a16:creationId xmlns:a16="http://schemas.microsoft.com/office/drawing/2014/main" id="{6608B892-BC61-43CB-A08A-4DA664E25B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7333" t="56401" r="52080" b="22614"/>
            <a:stretch/>
          </p:blipFill>
          <p:spPr>
            <a:xfrm>
              <a:off x="1285764" y="4084308"/>
              <a:ext cx="1793661" cy="926867"/>
            </a:xfrm>
            <a:prstGeom prst="rect">
              <a:avLst/>
            </a:prstGeom>
          </p:spPr>
        </p:pic>
        <p:sp>
          <p:nvSpPr>
            <p:cNvPr id="5" name="CasellaDiTesto 4">
              <a:extLst>
                <a:ext uri="{FF2B5EF4-FFF2-40B4-BE49-F238E27FC236}">
                  <a16:creationId xmlns:a16="http://schemas.microsoft.com/office/drawing/2014/main" id="{D94663DB-548E-4148-98DA-0DDE76FA2D25}"/>
                </a:ext>
              </a:extLst>
            </p:cNvPr>
            <p:cNvSpPr txBox="1"/>
            <p:nvPr/>
          </p:nvSpPr>
          <p:spPr>
            <a:xfrm>
              <a:off x="523190" y="1651358"/>
              <a:ext cx="23679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6" name="CasellaDiTesto 5">
              <a:extLst>
                <a:ext uri="{FF2B5EF4-FFF2-40B4-BE49-F238E27FC236}">
                  <a16:creationId xmlns:a16="http://schemas.microsoft.com/office/drawing/2014/main" id="{62384CCD-C717-45C7-96BE-85710BFA8090}"/>
                </a:ext>
              </a:extLst>
            </p:cNvPr>
            <p:cNvSpPr txBox="1"/>
            <p:nvPr/>
          </p:nvSpPr>
          <p:spPr>
            <a:xfrm>
              <a:off x="3658752" y="1646021"/>
              <a:ext cx="354983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2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B36885E8-E357-4B80-9BE4-B3859DF2EE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215394" y="2893856"/>
              <a:ext cx="1909454" cy="803042"/>
            </a:xfrm>
            <a:prstGeom prst="rect">
              <a:avLst/>
            </a:prstGeom>
          </p:spPr>
        </p:pic>
        <p:sp>
          <p:nvSpPr>
            <p:cNvPr id="10" name="CasellaDiTesto 150">
              <a:extLst>
                <a:ext uri="{FF2B5EF4-FFF2-40B4-BE49-F238E27FC236}">
                  <a16:creationId xmlns:a16="http://schemas.microsoft.com/office/drawing/2014/main" id="{E36B7F7B-58F1-469C-901B-A2594E7C4B5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46205" y="2970264"/>
              <a:ext cx="813219" cy="294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109198" tIns="54599" rIns="109198" bIns="54599">
              <a:spAutoFit/>
            </a:bodyPr>
            <a:lstStyle/>
            <a:p>
              <a:pPr eaLnBrk="1" hangingPunct="1"/>
              <a:r>
                <a:rPr lang="it-IT" alt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75 </a:t>
              </a:r>
              <a:r>
                <a:rPr lang="it-IT" alt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it-IT" alt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Connettore 1 8">
              <a:extLst>
                <a:ext uri="{FF2B5EF4-FFF2-40B4-BE49-F238E27FC236}">
                  <a16:creationId xmlns:a16="http://schemas.microsoft.com/office/drawing/2014/main" id="{884D117A-1367-4BA6-869C-2C9E18BA86B1}"/>
                </a:ext>
              </a:extLst>
            </p:cNvPr>
            <p:cNvCxnSpPr/>
            <p:nvPr/>
          </p:nvCxnSpPr>
          <p:spPr>
            <a:xfrm>
              <a:off x="850481" y="3266474"/>
              <a:ext cx="288000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CasellaDiTesto 150">
              <a:extLst>
                <a:ext uri="{FF2B5EF4-FFF2-40B4-BE49-F238E27FC236}">
                  <a16:creationId xmlns:a16="http://schemas.microsoft.com/office/drawing/2014/main" id="{BCBE0FE5-BF91-473A-8B69-D52D0EF845A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53722" y="4431376"/>
              <a:ext cx="723483" cy="29493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109198" tIns="54599" rIns="109198" bIns="54599">
              <a:spAutoFit/>
            </a:bodyPr>
            <a:lstStyle/>
            <a:p>
              <a:pPr eaLnBrk="1" hangingPunct="1"/>
              <a:r>
                <a:rPr lang="it-IT" alt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37 </a:t>
              </a:r>
              <a:r>
                <a:rPr lang="it-IT" alt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it-IT" altLang="it-IT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" name="Connettore 1 8">
              <a:extLst>
                <a:ext uri="{FF2B5EF4-FFF2-40B4-BE49-F238E27FC236}">
                  <a16:creationId xmlns:a16="http://schemas.microsoft.com/office/drawing/2014/main" id="{11661D46-44E0-473F-B4F8-0CAC3F76EBC7}"/>
                </a:ext>
              </a:extLst>
            </p:cNvPr>
            <p:cNvCxnSpPr/>
            <p:nvPr/>
          </p:nvCxnSpPr>
          <p:spPr>
            <a:xfrm>
              <a:off x="850481" y="4734783"/>
              <a:ext cx="288000" cy="0"/>
            </a:xfrm>
            <a:prstGeom prst="line">
              <a:avLst/>
            </a:prstGeom>
            <a:ln w="19050">
              <a:solidFill>
                <a:schemeClr val="bg2">
                  <a:lumMod val="2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6F2687B6-1F50-4DC2-8C33-317D41C2B5D3}"/>
                </a:ext>
              </a:extLst>
            </p:cNvPr>
            <p:cNvSpPr txBox="1"/>
            <p:nvPr/>
          </p:nvSpPr>
          <p:spPr>
            <a:xfrm>
              <a:off x="1785056" y="3723042"/>
              <a:ext cx="1099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3507349">
                <a:defRPr/>
              </a:pP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LT-1 IB</a:t>
              </a:r>
            </a:p>
          </p:txBody>
        </p:sp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AD978F5D-17EF-4293-B223-23F8C1349974}"/>
                </a:ext>
              </a:extLst>
            </p:cNvPr>
            <p:cNvSpPr txBox="1"/>
            <p:nvPr/>
          </p:nvSpPr>
          <p:spPr>
            <a:xfrm>
              <a:off x="1764362" y="4998026"/>
              <a:ext cx="1099201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defTabSz="3507349">
                <a:defRPr/>
              </a:pPr>
              <a:r>
                <a:rPr lang="it-IT" sz="1200" b="1" dirty="0"/>
                <a:t> </a:t>
              </a:r>
              <a:r>
                <a:rPr lang="el-G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IB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F57B4C00-FA59-4D15-A151-0CB6B4ADE0A0}"/>
                </a:ext>
              </a:extLst>
            </p:cNvPr>
            <p:cNvSpPr txBox="1"/>
            <p:nvPr/>
          </p:nvSpPr>
          <p:spPr>
            <a:xfrm rot="18397049">
              <a:off x="2192425" y="2182442"/>
              <a:ext cx="1428685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5 12-16 DOT</a:t>
              </a:r>
            </a:p>
          </p:txBody>
        </p:sp>
        <p:sp>
          <p:nvSpPr>
            <p:cNvPr id="19" name="CasellaDiTesto 18">
              <a:extLst>
                <a:ext uri="{FF2B5EF4-FFF2-40B4-BE49-F238E27FC236}">
                  <a16:creationId xmlns:a16="http://schemas.microsoft.com/office/drawing/2014/main" id="{67194AC3-08A8-4B55-9E0D-D83C5BEBFF90}"/>
                </a:ext>
              </a:extLst>
            </p:cNvPr>
            <p:cNvSpPr txBox="1"/>
            <p:nvPr/>
          </p:nvSpPr>
          <p:spPr>
            <a:xfrm rot="18470945">
              <a:off x="1154983" y="2167773"/>
              <a:ext cx="160410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it-IT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Ctrl</a:t>
              </a:r>
              <a:r>
                <a:rPr lang="it-IT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 12-16 DOT</a:t>
              </a:r>
            </a:p>
          </p:txBody>
        </p:sp>
      </p:grpSp>
      <p:sp>
        <p:nvSpPr>
          <p:cNvPr id="17" name="CasellaDiTesto 15">
            <a:extLst>
              <a:ext uri="{FF2B5EF4-FFF2-40B4-BE49-F238E27FC236}">
                <a16:creationId xmlns:a16="http://schemas.microsoft.com/office/drawing/2014/main" id="{A5867A11-FCF2-4C3A-9BD1-CC1D8FF30EB4}"/>
              </a:ext>
            </a:extLst>
          </p:cNvPr>
          <p:cNvSpPr txBox="1"/>
          <p:nvPr/>
        </p:nvSpPr>
        <p:spPr>
          <a:xfrm>
            <a:off x="364531" y="5916121"/>
            <a:ext cx="6210300" cy="1264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4 - Effect of long-term G5 treatment on the expression of the glutamate transporter GLT-1 in primary cortical astrocytes 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7000"/>
              </a:lnSpc>
            </a:pP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) Representative immunoblot of GLT-1 from lysate of untreated (Ctrl) and astrocytes treated for 12-16 days (12-16 DOT) with G5.  B) Densitometric analysis (n=3) of the immunoblot signals. </a:t>
            </a:r>
            <a:r>
              <a:rPr lang="en-US" sz="1200" kern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The antibody recognizes an immunoreactive band at ~70 </a:t>
            </a:r>
            <a:r>
              <a:rPr lang="en-US" sz="1200" kern="1200" dirty="0">
                <a:solidFill>
                  <a:srgbClr val="FF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200" kern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Da</a:t>
            </a:r>
            <a:r>
              <a:rPr lang="en-US" sz="1200" kern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* p&lt;0.01 with unpaired Student’s t test.</a:t>
            </a:r>
            <a:endParaRPr lang="en-GB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326133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</TotalTime>
  <Words>793</Words>
  <Application>Microsoft Office PowerPoint</Application>
  <PresentationFormat>Widescreen</PresentationFormat>
  <Paragraphs>97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Segoe UI</vt:lpstr>
      <vt:lpstr>Times New Roman</vt:lpstr>
      <vt:lpstr>Office Them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esco Formaggio</dc:creator>
  <cp:lastModifiedBy>stefano ferroni</cp:lastModifiedBy>
  <cp:revision>160</cp:revision>
  <dcterms:created xsi:type="dcterms:W3CDTF">2020-12-29T19:05:50Z</dcterms:created>
  <dcterms:modified xsi:type="dcterms:W3CDTF">2021-10-11T13:18:50Z</dcterms:modified>
</cp:coreProperties>
</file>